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5"/>
  </p:notesMasterIdLst>
  <p:sldIdLst>
    <p:sldId id="1100" r:id="rId2"/>
    <p:sldId id="1073" r:id="rId3"/>
    <p:sldId id="1084" r:id="rId4"/>
    <p:sldId id="1095" r:id="rId5"/>
    <p:sldId id="1090" r:id="rId6"/>
    <p:sldId id="1097" r:id="rId7"/>
    <p:sldId id="1077" r:id="rId8"/>
    <p:sldId id="1098" r:id="rId9"/>
    <p:sldId id="1099" r:id="rId10"/>
    <p:sldId id="1080" r:id="rId11"/>
    <p:sldId id="1096" r:id="rId12"/>
    <p:sldId id="1058" r:id="rId13"/>
    <p:sldId id="1078" r:id="rId14"/>
  </p:sldIdLst>
  <p:sldSz cx="18288000" cy="10287000"/>
  <p:notesSz cx="6858000" cy="9144000"/>
  <p:embeddedFontLst>
    <p:embeddedFont>
      <p:font typeface="Assistant" pitchFamily="2" charset="-79"/>
      <p:regular r:id="rId16"/>
      <p:bold r:id="rId17"/>
    </p:embeddedFont>
    <p:embeddedFont>
      <p:font typeface="Assistant Bold" charset="-79"/>
      <p:regular r:id="rId18"/>
      <p:bold r:id="rId19"/>
    </p:embeddedFont>
    <p:embeddedFont>
      <p:font typeface="Assistant ExtraBold" pitchFamily="2" charset="-79"/>
      <p:bold r:id="rId20"/>
    </p:embeddedFont>
    <p:embeddedFont>
      <p:font typeface="Assistant Regular" charset="-79"/>
      <p:regular r:id="rId21"/>
    </p:embeddedFont>
    <p:embeddedFont>
      <p:font typeface="Assistant SemiBold" pitchFamily="2" charset="-79"/>
      <p:bold r:id="rId22"/>
    </p:embeddedFont>
    <p:embeddedFont>
      <p:font typeface="Calibri" panose="020F0502020204030204" pitchFamily="34" charset="0"/>
      <p:regular r:id="rId23"/>
      <p:bold r:id="rId24"/>
      <p:italic r:id="rId25"/>
      <p:boldItalic r:id="rId26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3.fntdata"/><Relationship Id="rId26" Type="http://schemas.openxmlformats.org/officeDocument/2006/relationships/font" Target="fonts/font11.fntdata"/><Relationship Id="rId3" Type="http://schemas.openxmlformats.org/officeDocument/2006/relationships/slide" Target="slides/slide2.xml"/><Relationship Id="rId21" Type="http://schemas.openxmlformats.org/officeDocument/2006/relationships/font" Target="fonts/font6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2.fntdata"/><Relationship Id="rId25" Type="http://schemas.openxmlformats.org/officeDocument/2006/relationships/font" Target="fonts/font10.fntdata"/><Relationship Id="rId2" Type="http://schemas.openxmlformats.org/officeDocument/2006/relationships/slide" Target="slides/slide1.xml"/><Relationship Id="rId16" Type="http://schemas.openxmlformats.org/officeDocument/2006/relationships/font" Target="fonts/font1.fntdata"/><Relationship Id="rId20" Type="http://schemas.openxmlformats.org/officeDocument/2006/relationships/font" Target="fonts/font5.fntdata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9.fntdata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23" Type="http://schemas.openxmlformats.org/officeDocument/2006/relationships/font" Target="fonts/font8.fntdata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font" Target="fonts/font4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7.fntdata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6DBE21F1-FAC0-4F2D-ACD3-928E0867918E}" type="doc">
      <dgm:prSet loTypeId="urn:microsoft.com/office/officeart/2016/7/layout/VerticalHollowActionList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C838571A-BEF1-425D-8C08-9D7ABB2C97EC}">
      <dgm:prSet/>
      <dgm:spPr/>
      <dgm:t>
        <a:bodyPr/>
        <a:lstStyle/>
        <a:p>
          <a:r>
            <a:rPr lang="en-US"/>
            <a:t>Schedule</a:t>
          </a:r>
        </a:p>
      </dgm:t>
    </dgm:pt>
    <dgm:pt modelId="{9BD55028-97C1-4967-A5F2-FF6D10C4DE7D}" type="parTrans" cxnId="{56B434C6-286F-4417-8876-4546C146869F}">
      <dgm:prSet/>
      <dgm:spPr/>
      <dgm:t>
        <a:bodyPr/>
        <a:lstStyle/>
        <a:p>
          <a:endParaRPr lang="en-US"/>
        </a:p>
      </dgm:t>
    </dgm:pt>
    <dgm:pt modelId="{1BC4D8E5-7937-46FD-ABB0-A8B467E33BAC}" type="sibTrans" cxnId="{56B434C6-286F-4417-8876-4546C146869F}">
      <dgm:prSet/>
      <dgm:spPr/>
      <dgm:t>
        <a:bodyPr/>
        <a:lstStyle/>
        <a:p>
          <a:endParaRPr lang="en-US"/>
        </a:p>
      </dgm:t>
    </dgm:pt>
    <dgm:pt modelId="{D2674055-CA05-4D56-A4AF-E1F6305D86D3}">
      <dgm:prSet custT="1"/>
      <dgm:spPr/>
      <dgm:t>
        <a:bodyPr/>
        <a:lstStyle/>
        <a:p>
          <a:r>
            <a:rPr lang="en-US" sz="3200" dirty="0"/>
            <a:t>Schedule enjoyment in your life</a:t>
          </a:r>
        </a:p>
      </dgm:t>
    </dgm:pt>
    <dgm:pt modelId="{6A41988D-7088-4550-930F-6F72CAE460BE}" type="parTrans" cxnId="{E4D0731F-1DA2-4961-A05E-498E70AEF573}">
      <dgm:prSet/>
      <dgm:spPr/>
      <dgm:t>
        <a:bodyPr/>
        <a:lstStyle/>
        <a:p>
          <a:endParaRPr lang="en-US"/>
        </a:p>
      </dgm:t>
    </dgm:pt>
    <dgm:pt modelId="{71668495-150F-4005-8C66-45EE03E94036}" type="sibTrans" cxnId="{E4D0731F-1DA2-4961-A05E-498E70AEF573}">
      <dgm:prSet/>
      <dgm:spPr/>
      <dgm:t>
        <a:bodyPr/>
        <a:lstStyle/>
        <a:p>
          <a:endParaRPr lang="en-US"/>
        </a:p>
      </dgm:t>
    </dgm:pt>
    <dgm:pt modelId="{3A3649D6-04F2-415D-87FA-078C64F0DA67}">
      <dgm:prSet custT="1"/>
      <dgm:spPr/>
      <dgm:t>
        <a:bodyPr/>
        <a:lstStyle/>
        <a:p>
          <a:r>
            <a:rPr lang="en-US" sz="2400"/>
            <a:t>Make a list of things you enjoy</a:t>
          </a:r>
        </a:p>
      </dgm:t>
    </dgm:pt>
    <dgm:pt modelId="{401D3680-59F3-4A5B-8CBB-0AA40DE9E689}" type="parTrans" cxnId="{84ECE2C4-0D23-4042-9D07-C965990C9BC0}">
      <dgm:prSet/>
      <dgm:spPr/>
      <dgm:t>
        <a:bodyPr/>
        <a:lstStyle/>
        <a:p>
          <a:endParaRPr lang="en-US"/>
        </a:p>
      </dgm:t>
    </dgm:pt>
    <dgm:pt modelId="{0C719D18-0760-4930-9C9C-1F0B3E8722C7}" type="sibTrans" cxnId="{84ECE2C4-0D23-4042-9D07-C965990C9BC0}">
      <dgm:prSet/>
      <dgm:spPr/>
      <dgm:t>
        <a:bodyPr/>
        <a:lstStyle/>
        <a:p>
          <a:endParaRPr lang="en-US"/>
        </a:p>
      </dgm:t>
    </dgm:pt>
    <dgm:pt modelId="{9179F8EE-4623-43BA-AA24-F7E85AA1E503}">
      <dgm:prSet custT="1"/>
      <dgm:spPr/>
      <dgm:t>
        <a:bodyPr/>
        <a:lstStyle/>
        <a:p>
          <a:r>
            <a:rPr lang="en-US" sz="2400" dirty="0"/>
            <a:t>Maintain a schedule so you can always look forward </a:t>
          </a:r>
        </a:p>
      </dgm:t>
    </dgm:pt>
    <dgm:pt modelId="{FCBFD79F-DB8A-40E8-BE5C-3A1FB279E77C}" type="parTrans" cxnId="{0B51BE0C-1ADF-4FCF-AC8C-E5DAEFE91A28}">
      <dgm:prSet/>
      <dgm:spPr/>
      <dgm:t>
        <a:bodyPr/>
        <a:lstStyle/>
        <a:p>
          <a:endParaRPr lang="en-US"/>
        </a:p>
      </dgm:t>
    </dgm:pt>
    <dgm:pt modelId="{6CFEB714-AF31-4ECE-BE32-FF184681BCAA}" type="sibTrans" cxnId="{0B51BE0C-1ADF-4FCF-AC8C-E5DAEFE91A28}">
      <dgm:prSet/>
      <dgm:spPr/>
      <dgm:t>
        <a:bodyPr/>
        <a:lstStyle/>
        <a:p>
          <a:endParaRPr lang="en-US"/>
        </a:p>
      </dgm:t>
    </dgm:pt>
    <dgm:pt modelId="{C8DB762D-981D-4AE2-89C7-07E8D49A14E5}">
      <dgm:prSet custT="1"/>
      <dgm:spPr/>
      <dgm:t>
        <a:bodyPr/>
        <a:lstStyle/>
        <a:p>
          <a:r>
            <a:rPr lang="en-US" sz="2400" dirty="0"/>
            <a:t>Protect your good experiences– honor your schedule</a:t>
          </a:r>
          <a:r>
            <a:rPr lang="en-US" sz="1400" dirty="0"/>
            <a:t>!</a:t>
          </a:r>
        </a:p>
      </dgm:t>
    </dgm:pt>
    <dgm:pt modelId="{048B7F31-9F8B-4B6A-8273-C9CBCEEECE03}" type="parTrans" cxnId="{90AD693A-BCDB-491A-8E6F-1C98E7591606}">
      <dgm:prSet/>
      <dgm:spPr/>
      <dgm:t>
        <a:bodyPr/>
        <a:lstStyle/>
        <a:p>
          <a:endParaRPr lang="en-US"/>
        </a:p>
      </dgm:t>
    </dgm:pt>
    <dgm:pt modelId="{5106E1F7-BF0D-47FF-90D9-4ACAE3278628}" type="sibTrans" cxnId="{90AD693A-BCDB-491A-8E6F-1C98E7591606}">
      <dgm:prSet/>
      <dgm:spPr/>
      <dgm:t>
        <a:bodyPr/>
        <a:lstStyle/>
        <a:p>
          <a:endParaRPr lang="en-US"/>
        </a:p>
      </dgm:t>
    </dgm:pt>
    <dgm:pt modelId="{25D8B325-6304-4F24-AD5A-6EFCB8DDDCE2}">
      <dgm:prSet/>
      <dgm:spPr/>
      <dgm:t>
        <a:bodyPr/>
        <a:lstStyle/>
        <a:p>
          <a:r>
            <a:rPr lang="en-US" dirty="0"/>
            <a:t>Reconnect and Affirm</a:t>
          </a:r>
        </a:p>
      </dgm:t>
    </dgm:pt>
    <dgm:pt modelId="{A4C722B2-4392-45CF-93C4-A0C501520206}" type="parTrans" cxnId="{F2B46E17-DC7D-44CC-839D-F7532CEE7E18}">
      <dgm:prSet/>
      <dgm:spPr/>
      <dgm:t>
        <a:bodyPr/>
        <a:lstStyle/>
        <a:p>
          <a:endParaRPr lang="en-US"/>
        </a:p>
      </dgm:t>
    </dgm:pt>
    <dgm:pt modelId="{3637F5B8-B38E-4DCD-B89B-72EB863572BF}" type="sibTrans" cxnId="{F2B46E17-DC7D-44CC-839D-F7532CEE7E18}">
      <dgm:prSet/>
      <dgm:spPr/>
      <dgm:t>
        <a:bodyPr/>
        <a:lstStyle/>
        <a:p>
          <a:endParaRPr lang="en-US"/>
        </a:p>
      </dgm:t>
    </dgm:pt>
    <dgm:pt modelId="{BCE877E4-B5FE-42CD-A96A-D2E3C27790A8}">
      <dgm:prSet custT="1"/>
      <dgm:spPr/>
      <dgm:t>
        <a:bodyPr/>
        <a:lstStyle/>
        <a:p>
          <a:r>
            <a:rPr lang="en-US" sz="3200" dirty="0"/>
            <a:t>Reconnect &amp; Affirm your Goals </a:t>
          </a:r>
        </a:p>
      </dgm:t>
    </dgm:pt>
    <dgm:pt modelId="{4FAE9382-7095-41A8-85B4-B6C644D451FB}" type="parTrans" cxnId="{3EE09D12-148B-4D04-B05B-A018270649AC}">
      <dgm:prSet/>
      <dgm:spPr/>
      <dgm:t>
        <a:bodyPr/>
        <a:lstStyle/>
        <a:p>
          <a:endParaRPr lang="en-US"/>
        </a:p>
      </dgm:t>
    </dgm:pt>
    <dgm:pt modelId="{CE808C03-6F6C-4332-8D80-DFE91D8358D1}" type="sibTrans" cxnId="{3EE09D12-148B-4D04-B05B-A018270649AC}">
      <dgm:prSet/>
      <dgm:spPr/>
      <dgm:t>
        <a:bodyPr/>
        <a:lstStyle/>
        <a:p>
          <a:endParaRPr lang="en-US"/>
        </a:p>
      </dgm:t>
    </dgm:pt>
    <dgm:pt modelId="{F593F755-35BF-4D3A-B5B2-8EF63E75A161}">
      <dgm:prSet custT="1"/>
      <dgm:spPr/>
      <dgm:t>
        <a:bodyPr/>
        <a:lstStyle/>
        <a:p>
          <a:r>
            <a:rPr lang="en-US" sz="2400" dirty="0"/>
            <a:t>Refer to your reasons for improving your health</a:t>
          </a:r>
        </a:p>
      </dgm:t>
    </dgm:pt>
    <dgm:pt modelId="{9D304E49-9E59-4475-9085-07B5568C0191}" type="parTrans" cxnId="{047D38D9-0314-4F6D-9424-1C560AA81785}">
      <dgm:prSet/>
      <dgm:spPr/>
      <dgm:t>
        <a:bodyPr/>
        <a:lstStyle/>
        <a:p>
          <a:endParaRPr lang="en-US"/>
        </a:p>
      </dgm:t>
    </dgm:pt>
    <dgm:pt modelId="{9D92E59D-FEF5-488E-86F5-32E69F86BD14}" type="sibTrans" cxnId="{047D38D9-0314-4F6D-9424-1C560AA81785}">
      <dgm:prSet/>
      <dgm:spPr/>
      <dgm:t>
        <a:bodyPr/>
        <a:lstStyle/>
        <a:p>
          <a:endParaRPr lang="en-US"/>
        </a:p>
      </dgm:t>
    </dgm:pt>
    <dgm:pt modelId="{ABB68A2F-E898-4C3A-A19F-B6846F310431}">
      <dgm:prSet custT="1"/>
      <dgm:spPr/>
      <dgm:t>
        <a:bodyPr/>
        <a:lstStyle/>
        <a:p>
          <a:r>
            <a:rPr lang="en-US" sz="2400" dirty="0"/>
            <a:t>Add new reasons as they occur to you</a:t>
          </a:r>
        </a:p>
      </dgm:t>
    </dgm:pt>
    <dgm:pt modelId="{AB30198D-95C9-447B-BA83-F26DB3AC5E08}" type="parTrans" cxnId="{B9DE72D8-17C9-4F57-8932-A951166E78DD}">
      <dgm:prSet/>
      <dgm:spPr/>
      <dgm:t>
        <a:bodyPr/>
        <a:lstStyle/>
        <a:p>
          <a:endParaRPr lang="en-US"/>
        </a:p>
      </dgm:t>
    </dgm:pt>
    <dgm:pt modelId="{881703D3-787F-44AC-B2E7-EE77FEB06D71}" type="sibTrans" cxnId="{B9DE72D8-17C9-4F57-8932-A951166E78DD}">
      <dgm:prSet/>
      <dgm:spPr/>
      <dgm:t>
        <a:bodyPr/>
        <a:lstStyle/>
        <a:p>
          <a:endParaRPr lang="en-US"/>
        </a:p>
      </dgm:t>
    </dgm:pt>
    <dgm:pt modelId="{492720BB-7392-4F1A-83B9-6C9508DF52E2}">
      <dgm:prSet custT="1"/>
      <dgm:spPr/>
      <dgm:t>
        <a:bodyPr/>
        <a:lstStyle/>
        <a:p>
          <a:r>
            <a:rPr lang="en-US" sz="2400" dirty="0"/>
            <a:t>Repeat these to yourself as affirmations:</a:t>
          </a:r>
        </a:p>
      </dgm:t>
    </dgm:pt>
    <dgm:pt modelId="{2762BCC0-1ACD-4FDE-A73E-733A1DAADF75}" type="parTrans" cxnId="{E532985F-1652-4785-97B0-A69A6A9C75E8}">
      <dgm:prSet/>
      <dgm:spPr/>
      <dgm:t>
        <a:bodyPr/>
        <a:lstStyle/>
        <a:p>
          <a:endParaRPr lang="en-US"/>
        </a:p>
      </dgm:t>
    </dgm:pt>
    <dgm:pt modelId="{34C0A211-1460-493D-9CF4-507C99898457}" type="sibTrans" cxnId="{E532985F-1652-4785-97B0-A69A6A9C75E8}">
      <dgm:prSet/>
      <dgm:spPr/>
      <dgm:t>
        <a:bodyPr/>
        <a:lstStyle/>
        <a:p>
          <a:endParaRPr lang="en-US"/>
        </a:p>
      </dgm:t>
    </dgm:pt>
    <dgm:pt modelId="{20ECA11F-3F56-43B9-8DB2-BD41A5A1B02B}">
      <dgm:prSet/>
      <dgm:spPr/>
      <dgm:t>
        <a:bodyPr/>
        <a:lstStyle/>
        <a:p>
          <a:r>
            <a:rPr lang="en-US" dirty="0"/>
            <a:t>Forgive</a:t>
          </a:r>
        </a:p>
      </dgm:t>
    </dgm:pt>
    <dgm:pt modelId="{55999B4D-D6A4-4C01-A12F-A18CB871315D}" type="parTrans" cxnId="{059B78FB-2A9E-453F-B5C7-34D9362F6B70}">
      <dgm:prSet/>
      <dgm:spPr/>
      <dgm:t>
        <a:bodyPr/>
        <a:lstStyle/>
        <a:p>
          <a:endParaRPr lang="en-US"/>
        </a:p>
      </dgm:t>
    </dgm:pt>
    <dgm:pt modelId="{7D2EC5ED-C4E3-4D74-8B9C-1827ADAD4327}" type="sibTrans" cxnId="{059B78FB-2A9E-453F-B5C7-34D9362F6B70}">
      <dgm:prSet/>
      <dgm:spPr/>
      <dgm:t>
        <a:bodyPr/>
        <a:lstStyle/>
        <a:p>
          <a:endParaRPr lang="en-US"/>
        </a:p>
      </dgm:t>
    </dgm:pt>
    <dgm:pt modelId="{9E6CAEC4-06A2-4F21-8771-CCF3FB7BDD5F}">
      <dgm:prSet custT="1"/>
      <dgm:spPr/>
      <dgm:t>
        <a:bodyPr/>
        <a:lstStyle/>
        <a:p>
          <a:pPr>
            <a:lnSpc>
              <a:spcPct val="100000"/>
            </a:lnSpc>
          </a:pPr>
          <a:r>
            <a:rPr lang="en-US" sz="3200" dirty="0"/>
            <a:t>Be accountable – but FORGIVE yourself too</a:t>
          </a:r>
        </a:p>
      </dgm:t>
    </dgm:pt>
    <dgm:pt modelId="{38819E49-F4F5-467A-AB1E-B768CDE8938E}" type="parTrans" cxnId="{3C255C79-9784-4DC9-9634-C31349ABD350}">
      <dgm:prSet/>
      <dgm:spPr/>
      <dgm:t>
        <a:bodyPr/>
        <a:lstStyle/>
        <a:p>
          <a:endParaRPr lang="en-US"/>
        </a:p>
      </dgm:t>
    </dgm:pt>
    <dgm:pt modelId="{B39FD160-C276-4D02-8677-A83526BA67B3}" type="sibTrans" cxnId="{3C255C79-9784-4DC9-9634-C31349ABD350}">
      <dgm:prSet/>
      <dgm:spPr/>
      <dgm:t>
        <a:bodyPr/>
        <a:lstStyle/>
        <a:p>
          <a:endParaRPr lang="en-US"/>
        </a:p>
      </dgm:t>
    </dgm:pt>
    <dgm:pt modelId="{95283363-3906-4058-AC3B-2480DE452E46}">
      <dgm:prSet custT="1"/>
      <dgm:spPr/>
      <dgm:t>
        <a:bodyPr/>
        <a:lstStyle/>
        <a:p>
          <a:pPr>
            <a:lnSpc>
              <a:spcPct val="100000"/>
            </a:lnSpc>
          </a:pPr>
          <a:r>
            <a:rPr lang="en-US" sz="2000" dirty="0"/>
            <a:t>Forgive, but don’t forget, we learn from our slips!</a:t>
          </a:r>
        </a:p>
      </dgm:t>
    </dgm:pt>
    <dgm:pt modelId="{DDF75919-3489-49E3-BCBF-542AE06CCE39}" type="parTrans" cxnId="{64CA2EEA-288F-4738-A769-A1145AE77900}">
      <dgm:prSet/>
      <dgm:spPr/>
      <dgm:t>
        <a:bodyPr/>
        <a:lstStyle/>
        <a:p>
          <a:endParaRPr lang="en-US"/>
        </a:p>
      </dgm:t>
    </dgm:pt>
    <dgm:pt modelId="{30962F91-67AD-4460-BD22-A7B52AC6E88C}" type="sibTrans" cxnId="{64CA2EEA-288F-4738-A769-A1145AE77900}">
      <dgm:prSet/>
      <dgm:spPr/>
      <dgm:t>
        <a:bodyPr/>
        <a:lstStyle/>
        <a:p>
          <a:endParaRPr lang="en-US"/>
        </a:p>
      </dgm:t>
    </dgm:pt>
    <dgm:pt modelId="{0A1B01C5-B353-46FE-90E7-EFA5F2CD07C9}">
      <dgm:prSet custT="1"/>
      <dgm:spPr/>
      <dgm:t>
        <a:bodyPr/>
        <a:lstStyle/>
        <a:p>
          <a:pPr>
            <a:lnSpc>
              <a:spcPct val="100000"/>
            </a:lnSpc>
          </a:pPr>
          <a:r>
            <a:rPr lang="en-US" sz="2000" dirty="0"/>
            <a:t>Self-monitor weight, food logs and exercise logs</a:t>
          </a:r>
        </a:p>
      </dgm:t>
    </dgm:pt>
    <dgm:pt modelId="{A2939B63-0E74-4161-9E5E-9FC2BED22DBB}" type="parTrans" cxnId="{FB915911-D153-4C67-AEFD-7E13AC4090FB}">
      <dgm:prSet/>
      <dgm:spPr/>
      <dgm:t>
        <a:bodyPr/>
        <a:lstStyle/>
        <a:p>
          <a:endParaRPr lang="en-US"/>
        </a:p>
      </dgm:t>
    </dgm:pt>
    <dgm:pt modelId="{6E9E6ED3-B598-40DE-9F9F-49924F11B7F9}" type="sibTrans" cxnId="{FB915911-D153-4C67-AEFD-7E13AC4090FB}">
      <dgm:prSet/>
      <dgm:spPr/>
      <dgm:t>
        <a:bodyPr/>
        <a:lstStyle/>
        <a:p>
          <a:endParaRPr lang="en-US"/>
        </a:p>
      </dgm:t>
    </dgm:pt>
    <dgm:pt modelId="{03D3DCEE-5B52-4333-B591-29EBB9D19CA5}">
      <dgm:prSet custT="1"/>
      <dgm:spPr/>
      <dgm:t>
        <a:bodyPr/>
        <a:lstStyle/>
        <a:p>
          <a:pPr>
            <a:lnSpc>
              <a:spcPct val="100000"/>
            </a:lnSpc>
          </a:pPr>
          <a:r>
            <a:rPr lang="en-US" sz="2000" dirty="0"/>
            <a:t>Constantly self-improve, but no one is perfect!</a:t>
          </a:r>
        </a:p>
      </dgm:t>
    </dgm:pt>
    <dgm:pt modelId="{6CD576FC-383A-4374-888D-BE23D6668619}" type="parTrans" cxnId="{A7D0B32D-9BF3-415C-8ACA-560774126790}">
      <dgm:prSet/>
      <dgm:spPr/>
      <dgm:t>
        <a:bodyPr/>
        <a:lstStyle/>
        <a:p>
          <a:endParaRPr lang="en-US"/>
        </a:p>
      </dgm:t>
    </dgm:pt>
    <dgm:pt modelId="{3016FED2-48B3-43F4-9D3F-6EC6F46FB69B}" type="sibTrans" cxnId="{A7D0B32D-9BF3-415C-8ACA-560774126790}">
      <dgm:prSet/>
      <dgm:spPr/>
      <dgm:t>
        <a:bodyPr/>
        <a:lstStyle/>
        <a:p>
          <a:endParaRPr lang="en-US"/>
        </a:p>
      </dgm:t>
    </dgm:pt>
    <dgm:pt modelId="{C784F8BC-79FB-4C34-A00C-527DF828E425}">
      <dgm:prSet custT="1"/>
      <dgm:spPr/>
      <dgm:t>
        <a:bodyPr/>
        <a:lstStyle/>
        <a:p>
          <a:pPr>
            <a:lnSpc>
              <a:spcPct val="100000"/>
            </a:lnSpc>
          </a:pPr>
          <a:r>
            <a:rPr lang="en-US" sz="2000" dirty="0"/>
            <a:t>Keep track of progress</a:t>
          </a:r>
        </a:p>
      </dgm:t>
    </dgm:pt>
    <dgm:pt modelId="{9539B0F9-0472-4E28-B773-C3706585681B}" type="parTrans" cxnId="{31B99E3A-69B2-41BA-B28C-28CAE3AB2E29}">
      <dgm:prSet/>
      <dgm:spPr/>
      <dgm:t>
        <a:bodyPr/>
        <a:lstStyle/>
        <a:p>
          <a:endParaRPr lang="en-US"/>
        </a:p>
      </dgm:t>
    </dgm:pt>
    <dgm:pt modelId="{00C1CDD4-5A58-42DC-9914-A6C4B5265D8E}" type="sibTrans" cxnId="{31B99E3A-69B2-41BA-B28C-28CAE3AB2E29}">
      <dgm:prSet/>
      <dgm:spPr/>
      <dgm:t>
        <a:bodyPr/>
        <a:lstStyle/>
        <a:p>
          <a:endParaRPr lang="en-US"/>
        </a:p>
      </dgm:t>
    </dgm:pt>
    <dgm:pt modelId="{00C919A8-65FF-432C-8700-51C776FAC245}" type="pres">
      <dgm:prSet presAssocID="{6DBE21F1-FAC0-4F2D-ACD3-928E0867918E}" presName="Name0" presStyleCnt="0">
        <dgm:presLayoutVars>
          <dgm:dir/>
          <dgm:animLvl val="lvl"/>
          <dgm:resizeHandles val="exact"/>
        </dgm:presLayoutVars>
      </dgm:prSet>
      <dgm:spPr/>
    </dgm:pt>
    <dgm:pt modelId="{8837E6D0-D4E7-44B5-98D7-0FEC05C99DB3}" type="pres">
      <dgm:prSet presAssocID="{C838571A-BEF1-425D-8C08-9D7ABB2C97EC}" presName="linNode" presStyleCnt="0"/>
      <dgm:spPr/>
    </dgm:pt>
    <dgm:pt modelId="{D394B3D0-748D-4D17-874C-0C38C284D995}" type="pres">
      <dgm:prSet presAssocID="{C838571A-BEF1-425D-8C08-9D7ABB2C97EC}" presName="parentText" presStyleLbl="solidFgAcc1" presStyleIdx="0" presStyleCnt="3">
        <dgm:presLayoutVars>
          <dgm:chMax val="1"/>
          <dgm:bulletEnabled/>
        </dgm:presLayoutVars>
      </dgm:prSet>
      <dgm:spPr/>
    </dgm:pt>
    <dgm:pt modelId="{268D9A47-498F-454D-9C5D-4A9E867703A9}" type="pres">
      <dgm:prSet presAssocID="{C838571A-BEF1-425D-8C08-9D7ABB2C97EC}" presName="descendantText" presStyleLbl="alignNode1" presStyleIdx="0" presStyleCnt="3">
        <dgm:presLayoutVars>
          <dgm:bulletEnabled/>
        </dgm:presLayoutVars>
      </dgm:prSet>
      <dgm:spPr/>
    </dgm:pt>
    <dgm:pt modelId="{FC65E367-CB9C-4090-9375-7D4549DC4B3C}" type="pres">
      <dgm:prSet presAssocID="{1BC4D8E5-7937-46FD-ABB0-A8B467E33BAC}" presName="sp" presStyleCnt="0"/>
      <dgm:spPr/>
    </dgm:pt>
    <dgm:pt modelId="{607FAF5A-A762-45D8-B246-8F5F14135014}" type="pres">
      <dgm:prSet presAssocID="{25D8B325-6304-4F24-AD5A-6EFCB8DDDCE2}" presName="linNode" presStyleCnt="0"/>
      <dgm:spPr/>
    </dgm:pt>
    <dgm:pt modelId="{7E64D5D4-E3EA-48BE-A994-F00C226F9792}" type="pres">
      <dgm:prSet presAssocID="{25D8B325-6304-4F24-AD5A-6EFCB8DDDCE2}" presName="parentText" presStyleLbl="solidFgAcc1" presStyleIdx="1" presStyleCnt="3">
        <dgm:presLayoutVars>
          <dgm:chMax val="1"/>
          <dgm:bulletEnabled/>
        </dgm:presLayoutVars>
      </dgm:prSet>
      <dgm:spPr/>
    </dgm:pt>
    <dgm:pt modelId="{75EBFE06-DDAB-487B-9D75-679D0DD357C0}" type="pres">
      <dgm:prSet presAssocID="{25D8B325-6304-4F24-AD5A-6EFCB8DDDCE2}" presName="descendantText" presStyleLbl="alignNode1" presStyleIdx="1" presStyleCnt="3">
        <dgm:presLayoutVars>
          <dgm:bulletEnabled/>
        </dgm:presLayoutVars>
      </dgm:prSet>
      <dgm:spPr/>
    </dgm:pt>
    <dgm:pt modelId="{0CBD180E-11EC-42DA-BA48-45C320435F8D}" type="pres">
      <dgm:prSet presAssocID="{3637F5B8-B38E-4DCD-B89B-72EB863572BF}" presName="sp" presStyleCnt="0"/>
      <dgm:spPr/>
    </dgm:pt>
    <dgm:pt modelId="{43F6AE73-6064-43FC-AD84-09837798DCB3}" type="pres">
      <dgm:prSet presAssocID="{20ECA11F-3F56-43B9-8DB2-BD41A5A1B02B}" presName="linNode" presStyleCnt="0"/>
      <dgm:spPr/>
    </dgm:pt>
    <dgm:pt modelId="{8F8A3B36-1B17-461A-A618-FE98ABA1A115}" type="pres">
      <dgm:prSet presAssocID="{20ECA11F-3F56-43B9-8DB2-BD41A5A1B02B}" presName="parentText" presStyleLbl="solidFgAcc1" presStyleIdx="2" presStyleCnt="3">
        <dgm:presLayoutVars>
          <dgm:chMax val="1"/>
          <dgm:bulletEnabled/>
        </dgm:presLayoutVars>
      </dgm:prSet>
      <dgm:spPr/>
    </dgm:pt>
    <dgm:pt modelId="{9E4BBA36-9135-4D85-90F6-996B9D17477E}" type="pres">
      <dgm:prSet presAssocID="{20ECA11F-3F56-43B9-8DB2-BD41A5A1B02B}" presName="descendantText" presStyleLbl="alignNode1" presStyleIdx="2" presStyleCnt="3" custScaleY="123075">
        <dgm:presLayoutVars>
          <dgm:bulletEnabled/>
        </dgm:presLayoutVars>
      </dgm:prSet>
      <dgm:spPr/>
    </dgm:pt>
  </dgm:ptLst>
  <dgm:cxnLst>
    <dgm:cxn modelId="{BADE840A-2ABF-4A88-B9A2-7F182FAB5E05}" type="presOf" srcId="{492720BB-7392-4F1A-83B9-6C9508DF52E2}" destId="{75EBFE06-DDAB-487B-9D75-679D0DD357C0}" srcOrd="0" destOrd="3" presId="urn:microsoft.com/office/officeart/2016/7/layout/VerticalHollowActionList"/>
    <dgm:cxn modelId="{0B51BE0C-1ADF-4FCF-AC8C-E5DAEFE91A28}" srcId="{D2674055-CA05-4D56-A4AF-E1F6305D86D3}" destId="{9179F8EE-4623-43BA-AA24-F7E85AA1E503}" srcOrd="1" destOrd="0" parTransId="{FCBFD79F-DB8A-40E8-BE5C-3A1FB279E77C}" sibTransId="{6CFEB714-AF31-4ECE-BE32-FF184681BCAA}"/>
    <dgm:cxn modelId="{FB915911-D153-4C67-AEFD-7E13AC4090FB}" srcId="{9E6CAEC4-06A2-4F21-8771-CCF3FB7BDD5F}" destId="{0A1B01C5-B353-46FE-90E7-EFA5F2CD07C9}" srcOrd="1" destOrd="0" parTransId="{A2939B63-0E74-4161-9E5E-9FC2BED22DBB}" sibTransId="{6E9E6ED3-B598-40DE-9F9F-49924F11B7F9}"/>
    <dgm:cxn modelId="{3EE09D12-148B-4D04-B05B-A018270649AC}" srcId="{25D8B325-6304-4F24-AD5A-6EFCB8DDDCE2}" destId="{BCE877E4-B5FE-42CD-A96A-D2E3C27790A8}" srcOrd="0" destOrd="0" parTransId="{4FAE9382-7095-41A8-85B4-B6C644D451FB}" sibTransId="{CE808C03-6F6C-4332-8D80-DFE91D8358D1}"/>
    <dgm:cxn modelId="{F2B46E17-DC7D-44CC-839D-F7532CEE7E18}" srcId="{6DBE21F1-FAC0-4F2D-ACD3-928E0867918E}" destId="{25D8B325-6304-4F24-AD5A-6EFCB8DDDCE2}" srcOrd="1" destOrd="0" parTransId="{A4C722B2-4392-45CF-93C4-A0C501520206}" sibTransId="{3637F5B8-B38E-4DCD-B89B-72EB863572BF}"/>
    <dgm:cxn modelId="{C39A8F1C-EF99-4373-8218-026D225155C8}" type="presOf" srcId="{C8DB762D-981D-4AE2-89C7-07E8D49A14E5}" destId="{268D9A47-498F-454D-9C5D-4A9E867703A9}" srcOrd="0" destOrd="3" presId="urn:microsoft.com/office/officeart/2016/7/layout/VerticalHollowActionList"/>
    <dgm:cxn modelId="{E4D0731F-1DA2-4961-A05E-498E70AEF573}" srcId="{C838571A-BEF1-425D-8C08-9D7ABB2C97EC}" destId="{D2674055-CA05-4D56-A4AF-E1F6305D86D3}" srcOrd="0" destOrd="0" parTransId="{6A41988D-7088-4550-930F-6F72CAE460BE}" sibTransId="{71668495-150F-4005-8C66-45EE03E94036}"/>
    <dgm:cxn modelId="{3F2C4122-06A6-41EB-B6D8-24A52D81F94E}" type="presOf" srcId="{9E6CAEC4-06A2-4F21-8771-CCF3FB7BDD5F}" destId="{9E4BBA36-9135-4D85-90F6-996B9D17477E}" srcOrd="0" destOrd="0" presId="urn:microsoft.com/office/officeart/2016/7/layout/VerticalHollowActionList"/>
    <dgm:cxn modelId="{B5AEC223-EF9B-4F5F-B739-B8A22211BEFF}" type="presOf" srcId="{9179F8EE-4623-43BA-AA24-F7E85AA1E503}" destId="{268D9A47-498F-454D-9C5D-4A9E867703A9}" srcOrd="0" destOrd="2" presId="urn:microsoft.com/office/officeart/2016/7/layout/VerticalHollowActionList"/>
    <dgm:cxn modelId="{C2324526-DBE0-42CD-A4AD-B15FECEBB1A8}" type="presOf" srcId="{BCE877E4-B5FE-42CD-A96A-D2E3C27790A8}" destId="{75EBFE06-DDAB-487B-9D75-679D0DD357C0}" srcOrd="0" destOrd="0" presId="urn:microsoft.com/office/officeart/2016/7/layout/VerticalHollowActionList"/>
    <dgm:cxn modelId="{A7D0B32D-9BF3-415C-8ACA-560774126790}" srcId="{9E6CAEC4-06A2-4F21-8771-CCF3FB7BDD5F}" destId="{03D3DCEE-5B52-4333-B591-29EBB9D19CA5}" srcOrd="2" destOrd="0" parTransId="{6CD576FC-383A-4374-888D-BE23D6668619}" sibTransId="{3016FED2-48B3-43F4-9D3F-6EC6F46FB69B}"/>
    <dgm:cxn modelId="{90AD693A-BCDB-491A-8E6F-1C98E7591606}" srcId="{D2674055-CA05-4D56-A4AF-E1F6305D86D3}" destId="{C8DB762D-981D-4AE2-89C7-07E8D49A14E5}" srcOrd="2" destOrd="0" parTransId="{048B7F31-9F8B-4B6A-8273-C9CBCEEECE03}" sibTransId="{5106E1F7-BF0D-47FF-90D9-4ACAE3278628}"/>
    <dgm:cxn modelId="{31B99E3A-69B2-41BA-B28C-28CAE3AB2E29}" srcId="{9E6CAEC4-06A2-4F21-8771-CCF3FB7BDD5F}" destId="{C784F8BC-79FB-4C34-A00C-527DF828E425}" srcOrd="3" destOrd="0" parTransId="{9539B0F9-0472-4E28-B773-C3706585681B}" sibTransId="{00C1CDD4-5A58-42DC-9914-A6C4B5265D8E}"/>
    <dgm:cxn modelId="{F21ED85C-C736-4B79-9D0F-8AD73CA6C0AA}" type="presOf" srcId="{D2674055-CA05-4D56-A4AF-E1F6305D86D3}" destId="{268D9A47-498F-454D-9C5D-4A9E867703A9}" srcOrd="0" destOrd="0" presId="urn:microsoft.com/office/officeart/2016/7/layout/VerticalHollowActionList"/>
    <dgm:cxn modelId="{E532985F-1652-4785-97B0-A69A6A9C75E8}" srcId="{BCE877E4-B5FE-42CD-A96A-D2E3C27790A8}" destId="{492720BB-7392-4F1A-83B9-6C9508DF52E2}" srcOrd="2" destOrd="0" parTransId="{2762BCC0-1ACD-4FDE-A73E-733A1DAADF75}" sibTransId="{34C0A211-1460-493D-9CF4-507C99898457}"/>
    <dgm:cxn modelId="{39095560-5CF3-4421-A6EA-95489B67383A}" type="presOf" srcId="{95283363-3906-4058-AC3B-2480DE452E46}" destId="{9E4BBA36-9135-4D85-90F6-996B9D17477E}" srcOrd="0" destOrd="1" presId="urn:microsoft.com/office/officeart/2016/7/layout/VerticalHollowActionList"/>
    <dgm:cxn modelId="{D5615A46-6AB9-48F6-B37F-54924C020A98}" type="presOf" srcId="{0A1B01C5-B353-46FE-90E7-EFA5F2CD07C9}" destId="{9E4BBA36-9135-4D85-90F6-996B9D17477E}" srcOrd="0" destOrd="2" presId="urn:microsoft.com/office/officeart/2016/7/layout/VerticalHollowActionList"/>
    <dgm:cxn modelId="{1D6CED46-E410-4356-BFD6-04C2B5BEEC51}" type="presOf" srcId="{25D8B325-6304-4F24-AD5A-6EFCB8DDDCE2}" destId="{7E64D5D4-E3EA-48BE-A994-F00C226F9792}" srcOrd="0" destOrd="0" presId="urn:microsoft.com/office/officeart/2016/7/layout/VerticalHollowActionList"/>
    <dgm:cxn modelId="{5F296449-336F-459E-B307-8CB33D61DC05}" type="presOf" srcId="{20ECA11F-3F56-43B9-8DB2-BD41A5A1B02B}" destId="{8F8A3B36-1B17-461A-A618-FE98ABA1A115}" srcOrd="0" destOrd="0" presId="urn:microsoft.com/office/officeart/2016/7/layout/VerticalHollowActionList"/>
    <dgm:cxn modelId="{823FA44D-636D-40F8-B23B-EE8A92CAC54B}" type="presOf" srcId="{6DBE21F1-FAC0-4F2D-ACD3-928E0867918E}" destId="{00C919A8-65FF-432C-8700-51C776FAC245}" srcOrd="0" destOrd="0" presId="urn:microsoft.com/office/officeart/2016/7/layout/VerticalHollowActionList"/>
    <dgm:cxn modelId="{0F750471-89CE-49BC-B3AB-2F1C6C6C26A7}" type="presOf" srcId="{3A3649D6-04F2-415D-87FA-078C64F0DA67}" destId="{268D9A47-498F-454D-9C5D-4A9E867703A9}" srcOrd="0" destOrd="1" presId="urn:microsoft.com/office/officeart/2016/7/layout/VerticalHollowActionList"/>
    <dgm:cxn modelId="{3C255C79-9784-4DC9-9634-C31349ABD350}" srcId="{20ECA11F-3F56-43B9-8DB2-BD41A5A1B02B}" destId="{9E6CAEC4-06A2-4F21-8771-CCF3FB7BDD5F}" srcOrd="0" destOrd="0" parTransId="{38819E49-F4F5-467A-AB1E-B768CDE8938E}" sibTransId="{B39FD160-C276-4D02-8677-A83526BA67B3}"/>
    <dgm:cxn modelId="{6CBC32AC-AE16-4973-B7A8-4D39BC39E993}" type="presOf" srcId="{C784F8BC-79FB-4C34-A00C-527DF828E425}" destId="{9E4BBA36-9135-4D85-90F6-996B9D17477E}" srcOrd="0" destOrd="4" presId="urn:microsoft.com/office/officeart/2016/7/layout/VerticalHollowActionList"/>
    <dgm:cxn modelId="{241F5DB2-5308-4423-9102-C22EDDA42E08}" type="presOf" srcId="{C838571A-BEF1-425D-8C08-9D7ABB2C97EC}" destId="{D394B3D0-748D-4D17-874C-0C38C284D995}" srcOrd="0" destOrd="0" presId="urn:microsoft.com/office/officeart/2016/7/layout/VerticalHollowActionList"/>
    <dgm:cxn modelId="{B0C00DBD-D387-41BF-BF69-4FE19DB04C0D}" type="presOf" srcId="{F593F755-35BF-4D3A-B5B2-8EF63E75A161}" destId="{75EBFE06-DDAB-487B-9D75-679D0DD357C0}" srcOrd="0" destOrd="1" presId="urn:microsoft.com/office/officeart/2016/7/layout/VerticalHollowActionList"/>
    <dgm:cxn modelId="{84ECE2C4-0D23-4042-9D07-C965990C9BC0}" srcId="{D2674055-CA05-4D56-A4AF-E1F6305D86D3}" destId="{3A3649D6-04F2-415D-87FA-078C64F0DA67}" srcOrd="0" destOrd="0" parTransId="{401D3680-59F3-4A5B-8CBB-0AA40DE9E689}" sibTransId="{0C719D18-0760-4930-9C9C-1F0B3E8722C7}"/>
    <dgm:cxn modelId="{56B434C6-286F-4417-8876-4546C146869F}" srcId="{6DBE21F1-FAC0-4F2D-ACD3-928E0867918E}" destId="{C838571A-BEF1-425D-8C08-9D7ABB2C97EC}" srcOrd="0" destOrd="0" parTransId="{9BD55028-97C1-4967-A5F2-FF6D10C4DE7D}" sibTransId="{1BC4D8E5-7937-46FD-ABB0-A8B467E33BAC}"/>
    <dgm:cxn modelId="{B9DE72D8-17C9-4F57-8932-A951166E78DD}" srcId="{BCE877E4-B5FE-42CD-A96A-D2E3C27790A8}" destId="{ABB68A2F-E898-4C3A-A19F-B6846F310431}" srcOrd="1" destOrd="0" parTransId="{AB30198D-95C9-447B-BA83-F26DB3AC5E08}" sibTransId="{881703D3-787F-44AC-B2E7-EE77FEB06D71}"/>
    <dgm:cxn modelId="{047D38D9-0314-4F6D-9424-1C560AA81785}" srcId="{BCE877E4-B5FE-42CD-A96A-D2E3C27790A8}" destId="{F593F755-35BF-4D3A-B5B2-8EF63E75A161}" srcOrd="0" destOrd="0" parTransId="{9D304E49-9E59-4475-9085-07B5568C0191}" sibTransId="{9D92E59D-FEF5-488E-86F5-32E69F86BD14}"/>
    <dgm:cxn modelId="{DE3899E5-57B6-4D1D-A238-2BA6B05ED162}" type="presOf" srcId="{ABB68A2F-E898-4C3A-A19F-B6846F310431}" destId="{75EBFE06-DDAB-487B-9D75-679D0DD357C0}" srcOrd="0" destOrd="2" presId="urn:microsoft.com/office/officeart/2016/7/layout/VerticalHollowActionList"/>
    <dgm:cxn modelId="{64CA2EEA-288F-4738-A769-A1145AE77900}" srcId="{9E6CAEC4-06A2-4F21-8771-CCF3FB7BDD5F}" destId="{95283363-3906-4058-AC3B-2480DE452E46}" srcOrd="0" destOrd="0" parTransId="{DDF75919-3489-49E3-BCBF-542AE06CCE39}" sibTransId="{30962F91-67AD-4460-BD22-A7B52AC6E88C}"/>
    <dgm:cxn modelId="{059B78FB-2A9E-453F-B5C7-34D9362F6B70}" srcId="{6DBE21F1-FAC0-4F2D-ACD3-928E0867918E}" destId="{20ECA11F-3F56-43B9-8DB2-BD41A5A1B02B}" srcOrd="2" destOrd="0" parTransId="{55999B4D-D6A4-4C01-A12F-A18CB871315D}" sibTransId="{7D2EC5ED-C4E3-4D74-8B9C-1827ADAD4327}"/>
    <dgm:cxn modelId="{933DD9FE-46F4-427B-B835-2012008ABABD}" type="presOf" srcId="{03D3DCEE-5B52-4333-B591-29EBB9D19CA5}" destId="{9E4BBA36-9135-4D85-90F6-996B9D17477E}" srcOrd="0" destOrd="3" presId="urn:microsoft.com/office/officeart/2016/7/layout/VerticalHollowActionList"/>
    <dgm:cxn modelId="{882CCA80-C8BC-4FF0-AD5D-7CC281B30DD7}" type="presParOf" srcId="{00C919A8-65FF-432C-8700-51C776FAC245}" destId="{8837E6D0-D4E7-44B5-98D7-0FEC05C99DB3}" srcOrd="0" destOrd="0" presId="urn:microsoft.com/office/officeart/2016/7/layout/VerticalHollowActionList"/>
    <dgm:cxn modelId="{B1DFC848-A229-4EF9-B1BD-69B896CED4FC}" type="presParOf" srcId="{8837E6D0-D4E7-44B5-98D7-0FEC05C99DB3}" destId="{D394B3D0-748D-4D17-874C-0C38C284D995}" srcOrd="0" destOrd="0" presId="urn:microsoft.com/office/officeart/2016/7/layout/VerticalHollowActionList"/>
    <dgm:cxn modelId="{9D04B6B2-4B49-4B59-A1F3-96D62F0A49BF}" type="presParOf" srcId="{8837E6D0-D4E7-44B5-98D7-0FEC05C99DB3}" destId="{268D9A47-498F-454D-9C5D-4A9E867703A9}" srcOrd="1" destOrd="0" presId="urn:microsoft.com/office/officeart/2016/7/layout/VerticalHollowActionList"/>
    <dgm:cxn modelId="{18488AB0-6641-4263-A562-56707D811EF6}" type="presParOf" srcId="{00C919A8-65FF-432C-8700-51C776FAC245}" destId="{FC65E367-CB9C-4090-9375-7D4549DC4B3C}" srcOrd="1" destOrd="0" presId="urn:microsoft.com/office/officeart/2016/7/layout/VerticalHollowActionList"/>
    <dgm:cxn modelId="{DF038BA9-FE16-4CC7-AC95-4C60B3489E08}" type="presParOf" srcId="{00C919A8-65FF-432C-8700-51C776FAC245}" destId="{607FAF5A-A762-45D8-B246-8F5F14135014}" srcOrd="2" destOrd="0" presId="urn:microsoft.com/office/officeart/2016/7/layout/VerticalHollowActionList"/>
    <dgm:cxn modelId="{BF4310BF-5A79-4BB9-AA78-13B51DDD1655}" type="presParOf" srcId="{607FAF5A-A762-45D8-B246-8F5F14135014}" destId="{7E64D5D4-E3EA-48BE-A994-F00C226F9792}" srcOrd="0" destOrd="0" presId="urn:microsoft.com/office/officeart/2016/7/layout/VerticalHollowActionList"/>
    <dgm:cxn modelId="{9987D5EE-C6DD-481B-A6CF-9EBFD7834A82}" type="presParOf" srcId="{607FAF5A-A762-45D8-B246-8F5F14135014}" destId="{75EBFE06-DDAB-487B-9D75-679D0DD357C0}" srcOrd="1" destOrd="0" presId="urn:microsoft.com/office/officeart/2016/7/layout/VerticalHollowActionList"/>
    <dgm:cxn modelId="{463B3FD4-2F1C-4EDC-AF66-61451FF68F34}" type="presParOf" srcId="{00C919A8-65FF-432C-8700-51C776FAC245}" destId="{0CBD180E-11EC-42DA-BA48-45C320435F8D}" srcOrd="3" destOrd="0" presId="urn:microsoft.com/office/officeart/2016/7/layout/VerticalHollowActionList"/>
    <dgm:cxn modelId="{7BA09C81-927E-48E2-BA07-8AEB83E350C3}" type="presParOf" srcId="{00C919A8-65FF-432C-8700-51C776FAC245}" destId="{43F6AE73-6064-43FC-AD84-09837798DCB3}" srcOrd="4" destOrd="0" presId="urn:microsoft.com/office/officeart/2016/7/layout/VerticalHollowActionList"/>
    <dgm:cxn modelId="{1EFAB21D-A916-4598-B410-06672BCB4F1D}" type="presParOf" srcId="{43F6AE73-6064-43FC-AD84-09837798DCB3}" destId="{8F8A3B36-1B17-461A-A618-FE98ABA1A115}" srcOrd="0" destOrd="0" presId="urn:microsoft.com/office/officeart/2016/7/layout/VerticalHollowActionList"/>
    <dgm:cxn modelId="{232BC5E7-A235-4729-9615-4387307C0D1C}" type="presParOf" srcId="{43F6AE73-6064-43FC-AD84-09837798DCB3}" destId="{9E4BBA36-9135-4D85-90F6-996B9D17477E}" srcOrd="1" destOrd="0" presId="urn:microsoft.com/office/officeart/2016/7/layout/VerticalHollowActionList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68D9A47-498F-454D-9C5D-4A9E867703A9}">
      <dsp:nvSpPr>
        <dsp:cNvPr id="0" name=""/>
        <dsp:cNvSpPr/>
      </dsp:nvSpPr>
      <dsp:spPr>
        <a:xfrm>
          <a:off x="1876694" y="1391"/>
          <a:ext cx="7506778" cy="2457953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5652" tIns="624320" rIns="145652" bIns="624320" numCol="1" spcCol="1270" anchor="t" anchorCtr="0">
          <a:noAutofit/>
        </a:bodyPr>
        <a:lstStyle/>
        <a:p>
          <a:pPr marL="0" lvl="0" indent="0" algn="l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kern="1200" dirty="0"/>
            <a:t>Schedule enjoyment in your life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/>
            <a:t>Make a list of things you enjoy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/>
            <a:t>Maintain a schedule so you can always look forward 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/>
            <a:t>Protect your good experiences– honor your schedule</a:t>
          </a:r>
          <a:r>
            <a:rPr lang="en-US" sz="1400" kern="1200" dirty="0"/>
            <a:t>!</a:t>
          </a:r>
        </a:p>
      </dsp:txBody>
      <dsp:txXfrm>
        <a:off x="1876694" y="1391"/>
        <a:ext cx="7506778" cy="2457953"/>
      </dsp:txXfrm>
    </dsp:sp>
    <dsp:sp modelId="{D394B3D0-748D-4D17-874C-0C38C284D995}">
      <dsp:nvSpPr>
        <dsp:cNvPr id="0" name=""/>
        <dsp:cNvSpPr/>
      </dsp:nvSpPr>
      <dsp:spPr>
        <a:xfrm>
          <a:off x="0" y="1391"/>
          <a:ext cx="1876694" cy="2457953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308" tIns="242791" rIns="99308" bIns="242791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/>
            <a:t>Schedule</a:t>
          </a:r>
        </a:p>
      </dsp:txBody>
      <dsp:txXfrm>
        <a:off x="0" y="1391"/>
        <a:ext cx="1876694" cy="2457953"/>
      </dsp:txXfrm>
    </dsp:sp>
    <dsp:sp modelId="{75EBFE06-DDAB-487B-9D75-679D0DD357C0}">
      <dsp:nvSpPr>
        <dsp:cNvPr id="0" name=""/>
        <dsp:cNvSpPr/>
      </dsp:nvSpPr>
      <dsp:spPr>
        <a:xfrm>
          <a:off x="1876694" y="2606821"/>
          <a:ext cx="7506778" cy="2457953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5652" tIns="624320" rIns="145652" bIns="624320" numCol="1" spcCol="1270" anchor="t" anchorCtr="0">
          <a:noAutofit/>
        </a:bodyPr>
        <a:lstStyle/>
        <a:p>
          <a:pPr marL="0" lvl="0" indent="0" algn="l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kern="1200" dirty="0"/>
            <a:t>Reconnect &amp; Affirm your Goals 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/>
            <a:t>Refer to your reasons for improving your health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/>
            <a:t>Add new reasons as they occur to you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/>
            <a:t>Repeat these to yourself as affirmations:</a:t>
          </a:r>
        </a:p>
      </dsp:txBody>
      <dsp:txXfrm>
        <a:off x="1876694" y="2606821"/>
        <a:ext cx="7506778" cy="2457953"/>
      </dsp:txXfrm>
    </dsp:sp>
    <dsp:sp modelId="{7E64D5D4-E3EA-48BE-A994-F00C226F9792}">
      <dsp:nvSpPr>
        <dsp:cNvPr id="0" name=""/>
        <dsp:cNvSpPr/>
      </dsp:nvSpPr>
      <dsp:spPr>
        <a:xfrm>
          <a:off x="0" y="2606821"/>
          <a:ext cx="1876694" cy="2457953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308" tIns="242791" rIns="99308" bIns="242791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/>
            <a:t>Reconnect and Affirm</a:t>
          </a:r>
        </a:p>
      </dsp:txBody>
      <dsp:txXfrm>
        <a:off x="0" y="2606821"/>
        <a:ext cx="1876694" cy="2457953"/>
      </dsp:txXfrm>
    </dsp:sp>
    <dsp:sp modelId="{9E4BBA36-9135-4D85-90F6-996B9D17477E}">
      <dsp:nvSpPr>
        <dsp:cNvPr id="0" name=""/>
        <dsp:cNvSpPr/>
      </dsp:nvSpPr>
      <dsp:spPr>
        <a:xfrm>
          <a:off x="1874861" y="5212252"/>
          <a:ext cx="7499447" cy="302512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5510" tIns="624320" rIns="145510" bIns="624320" numCol="1" spcCol="1270" anchor="t" anchorCtr="0">
          <a:noAutofit/>
        </a:bodyPr>
        <a:lstStyle/>
        <a:p>
          <a:pPr marL="0" lvl="0" indent="0" algn="l" defTabSz="1422400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kern="1200" dirty="0"/>
            <a:t>Be accountable – but FORGIVE yourself too</a:t>
          </a:r>
        </a:p>
        <a:p>
          <a:pPr marL="228600" lvl="1" indent="-228600" algn="l" defTabSz="889000">
            <a:lnSpc>
              <a:spcPct val="10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000" kern="1200" dirty="0"/>
            <a:t>Forgive, but don’t forget, we learn from our slips!</a:t>
          </a:r>
        </a:p>
        <a:p>
          <a:pPr marL="228600" lvl="1" indent="-228600" algn="l" defTabSz="889000">
            <a:lnSpc>
              <a:spcPct val="10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000" kern="1200" dirty="0"/>
            <a:t>Self-monitor weight, food logs and exercise logs</a:t>
          </a:r>
        </a:p>
        <a:p>
          <a:pPr marL="228600" lvl="1" indent="-228600" algn="l" defTabSz="889000">
            <a:lnSpc>
              <a:spcPct val="10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000" kern="1200" dirty="0"/>
            <a:t>Constantly self-improve, but no one is perfect!</a:t>
          </a:r>
        </a:p>
        <a:p>
          <a:pPr marL="228600" lvl="1" indent="-228600" algn="l" defTabSz="889000">
            <a:lnSpc>
              <a:spcPct val="10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000" kern="1200" dirty="0"/>
            <a:t>Keep track of progress</a:t>
          </a:r>
        </a:p>
      </dsp:txBody>
      <dsp:txXfrm>
        <a:off x="1874861" y="5212252"/>
        <a:ext cx="7499447" cy="3025126"/>
      </dsp:txXfrm>
    </dsp:sp>
    <dsp:sp modelId="{8F8A3B36-1B17-461A-A618-FE98ABA1A115}">
      <dsp:nvSpPr>
        <dsp:cNvPr id="0" name=""/>
        <dsp:cNvSpPr/>
      </dsp:nvSpPr>
      <dsp:spPr>
        <a:xfrm>
          <a:off x="0" y="5495838"/>
          <a:ext cx="1874861" cy="2457953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211" tIns="242791" rIns="99211" bIns="242791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/>
            <a:t>Forgive</a:t>
          </a:r>
        </a:p>
      </dsp:txBody>
      <dsp:txXfrm>
        <a:off x="0" y="5495838"/>
        <a:ext cx="1874861" cy="2457953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16/7/layout/VerticalHollowActionList">
  <dgm:title val="Vertical Hollow Action List"/>
  <dgm:desc val="Use to show non-sequential or grouped lists of information. Works well with large amounts of text. All text has the same level of emphasis, and direction is not implied."/>
  <dgm:catLst>
    <dgm:cat type="list" pri="5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  <dgm:pt modelId="3">
          <dgm:prSet phldr="1"/>
        </dgm:pt>
        <dgm:pt modelId="31">
          <dgm:prSet phldr="1"/>
        </dgm:pt>
        <dgm:pt modelId="4">
          <dgm:prSet phldr="1"/>
        </dgm:pt>
        <dgm:pt modelId="41">
          <dgm:prSet phldr="1"/>
        </dgm:pt>
        <dgm:pt modelId="5">
          <dgm:prSet phldr="1"/>
        </dgm:pt>
        <dgm:pt modelId="51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7" srcId="0" destId="4" srcOrd="3" destOrd="0"/>
        <dgm:cxn modelId="8" srcId="0" destId="5" srcOrd="4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  <dgm:cxn modelId="53" srcId="5" destId="5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>
          <dgm:param type="linDir" val="fromT"/>
          <dgm:param type="nodeHorzAlign" val="l"/>
        </dgm:alg>
      </dgm:if>
      <dgm:else name="Name3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linNode" refType="h"/>
      <dgm:constr type="w" for="ch" forName="linNode" refType="w"/>
      <dgm:constr type="h" for="ch" forName="sp" refType="h" fact="0.06"/>
      <dgm:constr type="primFontSz" for="des" forName="parentText" op="equ" val="28"/>
      <dgm:constr type="primFontSz" for="des" forName="descendantText" refType="primFontSz" refFor="des" refForName="parentText" op="lte" fact="0.82"/>
      <dgm:constr type="primFontSz" for="des" forName="parentText" refType="primFontSz" refFor="des" refForName="descendantText" op="lte" fact="1.25"/>
    </dgm:constrLst>
    <dgm:ruleLst/>
    <dgm:forEach name="Name4" axis="ch" ptType="node">
      <dgm:layoutNode name="linNode">
        <dgm:choose name="Name5">
          <dgm:if name="Name6" func="var" arg="dir" op="equ" val="norm">
            <dgm:alg type="lin">
              <dgm:param type="linDir" val="fromL"/>
            </dgm:alg>
          </dgm:if>
          <dgm:else name="Name7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onstrLst>
          <dgm:constr type="w" for="ch" forName="parentText" refType="w" fact="0.2"/>
          <dgm:constr type="w" for="ch" forName="descendantText" refType="w" fact="0.8"/>
          <dgm:constr type="h" for="ch" forName="parentText" refType="h"/>
          <dgm:constr type="h" for="ch" forName="descendantText" refType="h" refFor="ch" refForName="parentText"/>
        </dgm:constrLst>
        <dgm:ruleLst/>
        <dgm:layoutNode name="parentText" styleLbl="solidFgAcc1">
          <dgm:varLst>
            <dgm:chMax val="1"/>
            <dgm:bulletEnabled/>
          </dgm:varLst>
          <dgm:alg type="tx"/>
          <dgm:shape xmlns:r="http://schemas.openxmlformats.org/officeDocument/2006/relationships" type="rect" r:blip="" zOrderOff="3">
            <dgm:adjLst/>
          </dgm:shape>
          <dgm:presOf axis="self" ptType="node"/>
          <dgm:constrLst>
            <dgm:constr type="tMarg" refType="h" fact="0.28"/>
            <dgm:constr type="bMarg" refType="h" fact="0.28"/>
            <dgm:constr type="lMarg" refType="w" fact="0.15"/>
            <dgm:constr type="rMarg" refType="w" fact="0.15"/>
          </dgm:constrLst>
          <dgm:ruleLst>
            <dgm:rule type="primFontSz" val="15" fact="NaN" max="NaN"/>
          </dgm:ruleLst>
        </dgm:layoutNode>
        <dgm:layoutNode name="descendantText" styleLbl="alignNode1">
          <dgm:varLst>
            <dgm:bulletEnabled/>
          </dgm:varLst>
          <dgm:alg type="tx">
            <dgm:param type="stBulletLvl" val="0"/>
            <dgm:param type="parTxLTRAlign" val="l"/>
            <dgm:param type="shpTxLTRAlignCh" val="l"/>
            <dgm:param type="parTxRTLAlign" val="r"/>
            <dgm:param type="shpTxRTLAlignCh" val="r"/>
          </dgm:alg>
          <dgm:choose name="Name10">
            <dgm:if name="Name11" func="var" arg="dir" op="equ" val="norm">
              <dgm:shape xmlns:r="http://schemas.openxmlformats.org/officeDocument/2006/relationships" type="rect" r:blip="">
                <dgm:adjLst/>
              </dgm:shape>
            </dgm:if>
            <dgm:else name="Name12">
              <dgm:shape xmlns:r="http://schemas.openxmlformats.org/officeDocument/2006/relationships" type="rect" r:blip="">
                <dgm:adjLst/>
              </dgm:shape>
            </dgm:else>
          </dgm:choose>
          <dgm:presOf axis="des" ptType="node"/>
          <dgm:constrLst>
            <dgm:constr type="primFontSz" val="24"/>
            <dgm:constr type="lMarg" refType="w" fact="0.055"/>
            <dgm:constr type="rMarg" refType="w" fact="0.055"/>
            <dgm:constr type="tMarg" refType="h" fact="0.72"/>
            <dgm:constr type="bMarg" refType="h" fact="0.72"/>
          </dgm:constrLst>
          <dgm:ruleLst>
            <dgm:rule type="primFontSz" val="11" fact="NaN" max="NaN"/>
          </dgm:ruleLst>
        </dgm:layoutNode>
      </dgm:layoutNode>
      <dgm:forEach name="Name14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1903401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3353326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05806915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29987147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5473653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33085661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040396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svg"/><Relationship Id="rId4" Type="http://schemas.openxmlformats.org/officeDocument/2006/relationships/image" Target="../media/image16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sv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svg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image" Target="../media/image14.jpeg"/><Relationship Id="rId7" Type="http://schemas.openxmlformats.org/officeDocument/2006/relationships/diagramColors" Target="../diagrams/colors1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4" Type="http://schemas.openxmlformats.org/officeDocument/2006/relationships/diagramData" Target="../diagrams/data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1134219"/>
            <a:chOff x="1573698" y="-152998"/>
            <a:chExt cx="7219847" cy="1512292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6999" y="-12404"/>
              <a:ext cx="7106546" cy="1231107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12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Stay Motivated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at have we changed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41403" y="2369646"/>
            <a:ext cx="14601344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What changes have you made to be more active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et up walking dates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alking Meeting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et reminders? 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eveloped new habits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What changes have you made to eat healthy more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tart with salad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wapped in healthy snacks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Retrained those taste buds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at more beans and plant-based proteins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DCC4AC5-8CF7-4DC4-95B1-9572B6938029}"/>
              </a:ext>
            </a:extLst>
          </p:cNvPr>
          <p:cNvSpPr txBox="1"/>
          <p:nvPr/>
        </p:nvSpPr>
        <p:spPr>
          <a:xfrm>
            <a:off x="1481414" y="1909531"/>
            <a:ext cx="16001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Switching to Every Other Week Sessions after this session!</a:t>
            </a:r>
          </a:p>
        </p:txBody>
      </p:sp>
      <p:pic>
        <p:nvPicPr>
          <p:cNvPr id="22" name="Picture 21" descr="Calendar page with a pen on top">
            <a:extLst>
              <a:ext uri="{FF2B5EF4-FFF2-40B4-BE49-F238E27FC236}">
                <a16:creationId xmlns:a16="http://schemas.microsoft.com/office/drawing/2014/main" id="{40933439-A155-4E3D-99C4-0961FFC9385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10" r="27310"/>
          <a:stretch/>
        </p:blipFill>
        <p:spPr>
          <a:xfrm>
            <a:off x="13453568" y="1909531"/>
            <a:ext cx="4186287" cy="61524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have we changed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47190" y="1709391"/>
            <a:ext cx="14601344" cy="89562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Does weighing everyday help you track what is working?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Yes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o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don’t weigh myself everyday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Does tracking your food/exercise help you adjust to stay on track?</a:t>
            </a: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Yes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o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don’t track my food/exercise everyday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Have you reached your </a:t>
            </a:r>
            <a:r>
              <a:rPr lang="en-US" sz="3200" b="1" i="1" dirty="0">
                <a:latin typeface="Assistant" pitchFamily="2" charset="-79"/>
                <a:cs typeface="Assistant" pitchFamily="2" charset="-79"/>
              </a:rPr>
              <a:t>FIRST </a:t>
            </a:r>
            <a:r>
              <a:rPr lang="en-US" sz="3200" b="1" dirty="0">
                <a:latin typeface="Assistant" pitchFamily="2" charset="-79"/>
                <a:cs typeface="Assistant" pitchFamily="2" charset="-79"/>
              </a:rPr>
              <a:t> weight loss goal?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o, not close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ot yet, but it’s close!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t’s fluctuating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Yes, just barely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Yes, I’m ready for the next goal level!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1428750" lvl="2" indent="-51435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22" name="Picture 21" descr="Calendar page with a pen on top">
            <a:extLst>
              <a:ext uri="{FF2B5EF4-FFF2-40B4-BE49-F238E27FC236}">
                <a16:creationId xmlns:a16="http://schemas.microsoft.com/office/drawing/2014/main" id="{40933439-A155-4E3D-99C4-0961FFC9385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10" r="27310" b="18950"/>
          <a:stretch/>
        </p:blipFill>
        <p:spPr>
          <a:xfrm>
            <a:off x="13453568" y="1909531"/>
            <a:ext cx="4186287" cy="4986569"/>
          </a:xfrm>
          <a:prstGeom prst="rect">
            <a:avLst/>
          </a:prstGeom>
        </p:spPr>
      </p:pic>
      <p:pic>
        <p:nvPicPr>
          <p:cNvPr id="6" name="Graphic 5" descr="Trophy with solid fill">
            <a:extLst>
              <a:ext uri="{FF2B5EF4-FFF2-40B4-BE49-F238E27FC236}">
                <a16:creationId xmlns:a16="http://schemas.microsoft.com/office/drawing/2014/main" id="{5D786C22-F7F7-4BEF-BEF3-8A0E8D8357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2036633" y="7853708"/>
            <a:ext cx="1785591" cy="178559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E01A0BE-CE44-41D0-8360-CB7A8C785DCB}"/>
              </a:ext>
            </a:extLst>
          </p:cNvPr>
          <p:cNvSpPr txBox="1"/>
          <p:nvPr/>
        </p:nvSpPr>
        <p:spPr>
          <a:xfrm>
            <a:off x="13944600" y="7658100"/>
            <a:ext cx="353881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Share your successes! Its always important to focus on your accomplishments, no matter how small. EVERYONE is successful if they </a:t>
            </a:r>
            <a:r>
              <a:rPr lang="en-US" sz="2400" b="1" u="sng" dirty="0"/>
              <a:t>keep showing up</a:t>
            </a:r>
            <a:r>
              <a:rPr lang="en-US" sz="2400" dirty="0"/>
              <a:t>!</a:t>
            </a:r>
          </a:p>
        </p:txBody>
      </p:sp>
    </p:spTree>
    <p:extLst>
      <p:ext uri="{BB962C8B-B14F-4D97-AF65-F5344CB8AC3E}">
        <p14:creationId xmlns:p14="http://schemas.microsoft.com/office/powerpoint/2010/main" val="278812963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87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Stay Motivates!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weight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more than 150 min of exercise this week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25 minutes or more moderate or vigorous! 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dd another 250 steps to each day, and get all 9 hours active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Use your activity planner and record your 10min+ successe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Make a stress resilience plan that includes scheduling enjoyment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a plan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Come with a story to tell!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59923" y="8313008"/>
            <a:ext cx="1382348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Staying motivated is a garden you cultivate over time</a:t>
            </a:r>
          </a:p>
          <a:p>
            <a:r>
              <a:rPr lang="en-US" sz="2800" dirty="0"/>
              <a:t>Motivation naturally comes and goes, so we build routines, habits, goals and commitments to keep progress moving forward. Say your affirmations daily to keep going on the healthy path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e your physical activity! 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activity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9895" y="8059937"/>
            <a:ext cx="12316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Achieving your short-term goals is a great way to stay motivated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After a little while healthy living will naturally reduce your stress levels too!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WEEK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weight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Tx/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manage those social cues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increase your daily steps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y do we try to prevent diabete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1445624" cy="79714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Risk factors for diabetes are similar for many chronic diseases– how do chronic illnesses impact us? (select all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edical costs go up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ess time with loved ones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ore pain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ore medication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ot able to do things you once enjoye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on’t feel like your former self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ired all the ti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orried a lot about the future or your health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Women in a marathon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972801" y="3674255"/>
            <a:ext cx="6632274" cy="4421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4051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can we prevent diabete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1445624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are the ways we can help prevent diabetes and choose healthy aging? (select all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aintain a healthy weigh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at lots of fruit, veggies, and whole grains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imit saturated fat and added suga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it less and move m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et in some moderate and vigorous exercise weekl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ake social events activ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Cook more at ho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Seniors bowling team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972801" y="3674255"/>
            <a:ext cx="6632274" cy="4421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377242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6951842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taying Motivated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424153" y="2013003"/>
            <a:ext cx="10479651" cy="6740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b="1" dirty="0">
                <a:latin typeface="Assistant Regular" charset="-79"/>
                <a:cs typeface="Assistant Regular" charset="-79"/>
              </a:rPr>
              <a:t>Health is a lifelong journey, not a destination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Keep your eye on what you hope to achieve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Honor your progress, but don’t settle, keep going!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Recognize and celebrate your successes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What healthy changes are you proud of?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What was easy? What was hard?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Decorate your environment with signs of success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Make a milestone map, its satisfying to check off boxes!</a:t>
            </a:r>
          </a:p>
          <a:p>
            <a:pPr marL="514350" indent="-514350">
              <a:buAutoNum type="arabicPeriod"/>
            </a:pPr>
            <a:r>
              <a:rPr lang="en-US" sz="3200" dirty="0">
                <a:latin typeface="Assistant Regular" charset="-79"/>
                <a:cs typeface="Assistant Regular" charset="-79"/>
              </a:rPr>
              <a:t>Shake things up from time to time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Chase away boredom and plateaus with something new</a:t>
            </a:r>
          </a:p>
          <a:p>
            <a:pPr marL="514350" indent="-514350">
              <a:buAutoNum type="arabicPeriod" startAt="5"/>
            </a:pPr>
            <a:r>
              <a:rPr lang="en-US" sz="3200" dirty="0">
                <a:latin typeface="Assistant Regular" charset="-79"/>
                <a:cs typeface="Assistant Regular" charset="-79"/>
              </a:rPr>
              <a:t>Turn progress into a game or friendly competition!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 Regular" charset="-79"/>
                <a:cs typeface="Assistant Regular" charset="-79"/>
              </a:rPr>
              <a:t>Ask a friend or fellow group member – you both win!</a:t>
            </a:r>
          </a:p>
          <a:p>
            <a:pPr marL="514350" indent="-514350">
              <a:buAutoNum type="arabicPeriod" startAt="6"/>
            </a:pPr>
            <a:r>
              <a:rPr lang="en-US" sz="3200" dirty="0">
                <a:latin typeface="Assistant Regular" charset="-79"/>
                <a:cs typeface="Assistant Regular" charset="-79"/>
              </a:rPr>
              <a:t>Phone a friend</a:t>
            </a:r>
          </a:p>
          <a:p>
            <a:pPr lvl="2"/>
            <a:r>
              <a:rPr lang="en-US" sz="2800" dirty="0">
                <a:latin typeface="Assistant Regular" charset="-79"/>
                <a:cs typeface="Assistant Regular" charset="-79"/>
              </a:rPr>
              <a:t>Reach out to someone supportive for some encouragement</a:t>
            </a:r>
          </a:p>
        </p:txBody>
      </p:sp>
      <p:pic>
        <p:nvPicPr>
          <p:cNvPr id="22" name="Picture 4" descr="View of ocean from sailboat">
            <a:extLst>
              <a:ext uri="{FF2B5EF4-FFF2-40B4-BE49-F238E27FC236}">
                <a16:creationId xmlns:a16="http://schemas.microsoft.com/office/drawing/2014/main" id="{BD98646B-55E2-46DA-9852-ABD8E5CB9A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95" r="7795"/>
          <a:stretch/>
        </p:blipFill>
        <p:spPr bwMode="auto">
          <a:xfrm>
            <a:off x="11658755" y="2729736"/>
            <a:ext cx="6114747" cy="48275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Chili Pepper outline">
            <a:extLst>
              <a:ext uri="{FF2B5EF4-FFF2-40B4-BE49-F238E27FC236}">
                <a16:creationId xmlns:a16="http://schemas.microsoft.com/office/drawing/2014/main" id="{C8523ECA-E98A-49C8-A136-C4E7E2D64A7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1061325" y="8833341"/>
            <a:ext cx="1531577" cy="15315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54B90BA-C379-4186-95B4-8C2121703A8E}"/>
              </a:ext>
            </a:extLst>
          </p:cNvPr>
          <p:cNvSpPr txBox="1"/>
          <p:nvPr/>
        </p:nvSpPr>
        <p:spPr>
          <a:xfrm>
            <a:off x="2667000" y="9183632"/>
            <a:ext cx="131826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Spice things up! Change up your flavors with a Mexican or Indian night, schedule a Meatless Monday, subscribe to a recipe magazine, or sign up for a cooking class! </a:t>
            </a:r>
          </a:p>
        </p:txBody>
      </p:sp>
    </p:spTree>
    <p:extLst>
      <p:ext uri="{BB962C8B-B14F-4D97-AF65-F5344CB8AC3E}">
        <p14:creationId xmlns:p14="http://schemas.microsoft.com/office/powerpoint/2010/main" val="5959177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Managing Str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497724" y="1817689"/>
            <a:ext cx="16176705" cy="19242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800" b="1" dirty="0"/>
              <a:t>Stress is an unavoidable part of life, but how we manage and recover from stressful situations is highly related to health and success reaching our goals.</a:t>
            </a:r>
          </a:p>
          <a:p>
            <a:pPr lvl="1">
              <a:lnSpc>
                <a:spcPct val="150000"/>
              </a:lnSpc>
            </a:pPr>
            <a:endParaRPr lang="en-US" sz="3200" dirty="0"/>
          </a:p>
        </p:txBody>
      </p:sp>
      <p:pic>
        <p:nvPicPr>
          <p:cNvPr id="2050" name="Picture 2" descr="Torn rope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180129" y="3461273"/>
            <a:ext cx="6444223" cy="42984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1A55BA44-9DD6-42B3-A08A-5D6458EB57C4}"/>
              </a:ext>
            </a:extLst>
          </p:cNvPr>
          <p:cNvSpPr txBox="1"/>
          <p:nvPr/>
        </p:nvSpPr>
        <p:spPr>
          <a:xfrm>
            <a:off x="1592215" y="3463684"/>
            <a:ext cx="9383473" cy="56938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4400" dirty="0"/>
              <a:t>Voluntary Reactions to Stress 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600" dirty="0"/>
              <a:t>Eating too much or eating enough</a:t>
            </a:r>
          </a:p>
          <a:p>
            <a:pPr lvl="4"/>
            <a:r>
              <a:rPr lang="en-US" sz="3600" dirty="0">
                <a:sym typeface="Wingdings" panose="05000000000000000000" pitchFamily="2" charset="2"/>
              </a:rPr>
              <a:t> Both unhelpful!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600" dirty="0">
                <a:sym typeface="Wingdings" panose="05000000000000000000" pitchFamily="2" charset="2"/>
              </a:rPr>
              <a:t>Becoming withdrawn or sedentary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600" dirty="0">
                <a:sym typeface="Wingdings" panose="05000000000000000000" pitchFamily="2" charset="2"/>
              </a:rPr>
              <a:t>Taking risks, like drinking alcohol</a:t>
            </a:r>
          </a:p>
          <a:p>
            <a:pPr lvl="2"/>
            <a:endParaRPr lang="en-US" dirty="0">
              <a:sym typeface="Wingdings" panose="05000000000000000000" pitchFamily="2" charset="2"/>
            </a:endParaRPr>
          </a:p>
          <a:p>
            <a:pPr lvl="2"/>
            <a:endParaRPr lang="en-US" dirty="0">
              <a:sym typeface="Wingdings" panose="05000000000000000000" pitchFamily="2" charset="2"/>
            </a:endParaRPr>
          </a:p>
          <a:p>
            <a:pPr lvl="2"/>
            <a:endParaRPr lang="en-US" dirty="0">
              <a:sym typeface="Wingdings" panose="05000000000000000000" pitchFamily="2" charset="2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4400" dirty="0">
                <a:sym typeface="Wingdings" panose="05000000000000000000" pitchFamily="2" charset="2"/>
              </a:rPr>
              <a:t>Involuntary Reactions to Stres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600" dirty="0">
                <a:sym typeface="Wingdings" panose="05000000000000000000" pitchFamily="2" charset="2"/>
              </a:rPr>
              <a:t>Headaches, stomach aches, muscle ach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400" dirty="0">
              <a:sym typeface="Wingdings" panose="05000000000000000000" pitchFamily="2" charset="2"/>
            </a:endParaRPr>
          </a:p>
          <a:p>
            <a:pPr lvl="2"/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38197424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Responding to Str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A55BA44-9DD6-42B3-A08A-5D6458EB57C4}"/>
              </a:ext>
            </a:extLst>
          </p:cNvPr>
          <p:cNvSpPr txBox="1"/>
          <p:nvPr/>
        </p:nvSpPr>
        <p:spPr>
          <a:xfrm>
            <a:off x="1606449" y="1857730"/>
            <a:ext cx="9383473" cy="87408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endParaRPr lang="en-US" sz="1400" dirty="0">
              <a:sym typeface="Wingdings" panose="05000000000000000000" pitchFamily="2" charset="2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>
                <a:sym typeface="Wingdings" panose="05000000000000000000" pitchFamily="2" charset="2"/>
              </a:rPr>
              <a:t>Choices in the face of stres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Say no, even for short-term stress to prevent long-term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Ask for help, get support when prioritizing your health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Set goals you can reach, and focus on the goal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Make a schedule with the real world in mind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Get organized, chaos creates problems 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Plan ahead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Keep things in perspective, one day at a time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endParaRPr lang="en-US" sz="2800" dirty="0">
              <a:sym typeface="Wingdings" panose="05000000000000000000" pitchFamily="2" charset="2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>
                <a:sym typeface="Wingdings" panose="05000000000000000000" pitchFamily="2" charset="2"/>
              </a:rPr>
              <a:t>When you can’t avoid the stres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Be aware that you are stressed, maintain control of your actions and behavior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Recognize the signs and trigger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Take a time out, pamper yourself!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Get moving- exercise helps reduce feelings of stres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Breathe, mindful breathing reduces feelings of stres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Do some meal prep, chopping can be meditative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800" dirty="0">
              <a:sym typeface="Wingdings" panose="05000000000000000000" pitchFamily="2" charset="2"/>
            </a:endParaRPr>
          </a:p>
          <a:p>
            <a:pPr marL="1200150" lvl="2" indent="-285750">
              <a:buFont typeface="Arial" panose="020B0604020202020204" pitchFamily="34" charset="0"/>
              <a:buChar char="•"/>
            </a:pPr>
            <a:endParaRPr lang="en-US" sz="2800" dirty="0"/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D4613DB3-6484-491A-A617-672D2D5C76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53800" y="3403900"/>
            <a:ext cx="6127684" cy="39217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et New Goals to Buffer Yourself from Str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A55BA44-9DD6-42B3-A08A-5D6458EB57C4}"/>
              </a:ext>
            </a:extLst>
          </p:cNvPr>
          <p:cNvSpPr txBox="1"/>
          <p:nvPr/>
        </p:nvSpPr>
        <p:spPr>
          <a:xfrm>
            <a:off x="1356050" y="1857730"/>
            <a:ext cx="9383473" cy="7017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endParaRPr lang="en-US" sz="1400" dirty="0">
              <a:sym typeface="Wingdings" panose="05000000000000000000" pitchFamily="2" charset="2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>
                <a:sym typeface="Wingdings" panose="05000000000000000000" pitchFamily="2" charset="2"/>
              </a:rPr>
              <a:t>Short, achievable goal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Just enough of a challenge, but not too hard</a:t>
            </a:r>
          </a:p>
          <a:p>
            <a:pPr marL="2114550" lvl="4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“I won’t eat potato chips this week”</a:t>
            </a:r>
          </a:p>
          <a:p>
            <a:pPr marL="2114550" lvl="4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“I will take an extra lap around my block today”</a:t>
            </a:r>
          </a:p>
          <a:p>
            <a:pPr marL="2114550" lvl="4" indent="-285750">
              <a:buFont typeface="Arial" panose="020B0604020202020204" pitchFamily="34" charset="0"/>
              <a:buChar char="•"/>
            </a:pPr>
            <a:endParaRPr lang="en-US" sz="2800" dirty="0">
              <a:sym typeface="Wingdings" panose="05000000000000000000" pitchFamily="2" charset="2"/>
            </a:endParaRPr>
          </a:p>
          <a:p>
            <a:pPr lvl="4"/>
            <a:endParaRPr lang="en-US" sz="2800" dirty="0">
              <a:sym typeface="Wingdings" panose="05000000000000000000" pitchFamily="2" charset="2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>
                <a:sym typeface="Wingdings" panose="05000000000000000000" pitchFamily="2" charset="2"/>
              </a:rPr>
              <a:t>Reward yourself when reaching goal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A nice reward that doesn’t cost a lot but you value</a:t>
            </a:r>
          </a:p>
          <a:p>
            <a:pPr marL="2114550" lvl="4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A bubble bath</a:t>
            </a:r>
          </a:p>
          <a:p>
            <a:pPr marL="2114550" lvl="4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A chat with friends or family sharing good news</a:t>
            </a:r>
          </a:p>
          <a:p>
            <a:pPr marL="2114550" lvl="4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A book on tape, or curling up with a good book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>
                <a:sym typeface="Wingdings" panose="05000000000000000000" pitchFamily="2" charset="2"/>
              </a:rPr>
              <a:t>Don’t reward with food– this is key!</a:t>
            </a:r>
          </a:p>
          <a:p>
            <a:pPr lvl="2"/>
            <a:endParaRPr lang="en-US" sz="2800" dirty="0">
              <a:sym typeface="Wingdings" panose="05000000000000000000" pitchFamily="2" charset="2"/>
            </a:endParaRPr>
          </a:p>
          <a:p>
            <a:endParaRPr lang="en-US" sz="2800" dirty="0">
              <a:sym typeface="Wingdings" panose="05000000000000000000" pitchFamily="2" charset="2"/>
            </a:endParaRPr>
          </a:p>
          <a:p>
            <a:pPr marL="1200150" lvl="2" indent="-285750">
              <a:buFont typeface="Arial" panose="020B0604020202020204" pitchFamily="34" charset="0"/>
              <a:buChar char="•"/>
            </a:pPr>
            <a:endParaRPr lang="en-US" sz="2800" dirty="0"/>
          </a:p>
        </p:txBody>
      </p:sp>
      <p:pic>
        <p:nvPicPr>
          <p:cNvPr id="1026" name="Picture 2" descr="Dog in lap">
            <a:extLst>
              <a:ext uri="{FF2B5EF4-FFF2-40B4-BE49-F238E27FC236}">
                <a16:creationId xmlns:a16="http://schemas.microsoft.com/office/drawing/2014/main" id="{D4613DB3-6484-491A-A617-672D2D5C76B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643" r="11314"/>
          <a:stretch/>
        </p:blipFill>
        <p:spPr bwMode="auto">
          <a:xfrm>
            <a:off x="10834773" y="3304158"/>
            <a:ext cx="6924261" cy="34013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Wreath with solid fill">
            <a:extLst>
              <a:ext uri="{FF2B5EF4-FFF2-40B4-BE49-F238E27FC236}">
                <a16:creationId xmlns:a16="http://schemas.microsoft.com/office/drawing/2014/main" id="{42EDC246-E46E-4D2F-88D9-BBD5C4422B3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894490" y="8254417"/>
            <a:ext cx="1534510" cy="15345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A47DB50-A652-4779-9C15-25DD609F7F44}"/>
              </a:ext>
            </a:extLst>
          </p:cNvPr>
          <p:cNvSpPr txBox="1"/>
          <p:nvPr/>
        </p:nvSpPr>
        <p:spPr>
          <a:xfrm>
            <a:off x="3619500" y="8430938"/>
            <a:ext cx="110490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What are your favorite NON-FOOD related rewards?</a:t>
            </a:r>
          </a:p>
          <a:p>
            <a:endParaRPr lang="en-US" sz="1400" dirty="0"/>
          </a:p>
          <a:p>
            <a:r>
              <a:rPr lang="en-US" sz="3200" dirty="0"/>
              <a:t>Put them in the chat or share with the group!</a:t>
            </a:r>
          </a:p>
        </p:txBody>
      </p:sp>
    </p:spTree>
    <p:extLst>
      <p:ext uri="{BB962C8B-B14F-4D97-AF65-F5344CB8AC3E}">
        <p14:creationId xmlns:p14="http://schemas.microsoft.com/office/powerpoint/2010/main" val="36265396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etting Yourself Up for Succ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22" name="Picture 2" descr="Football goal in the net">
            <a:extLst>
              <a:ext uri="{FF2B5EF4-FFF2-40B4-BE49-F238E27FC236}">
                <a16:creationId xmlns:a16="http://schemas.microsoft.com/office/drawing/2014/main" id="{A83DAD9E-154F-4A7F-AEBB-48880A7338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248" b="13248"/>
          <a:stretch/>
        </p:blipFill>
        <p:spPr bwMode="auto">
          <a:xfrm>
            <a:off x="10824439" y="3997494"/>
            <a:ext cx="6924261" cy="34013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4" name="TextBox 16">
            <a:extLst>
              <a:ext uri="{FF2B5EF4-FFF2-40B4-BE49-F238E27FC236}">
                <a16:creationId xmlns:a16="http://schemas.microsoft.com/office/drawing/2014/main" id="{673B2754-E627-07DE-F5CC-BA9BAE8F6C0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105696136"/>
              </p:ext>
            </p:extLst>
          </p:nvPr>
        </p:nvGraphicFramePr>
        <p:xfrm>
          <a:off x="1356050" y="1857730"/>
          <a:ext cx="9383473" cy="823877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</p:spTree>
    <p:extLst>
      <p:ext uri="{BB962C8B-B14F-4D97-AF65-F5344CB8AC3E}">
        <p14:creationId xmlns:p14="http://schemas.microsoft.com/office/powerpoint/2010/main" val="3299123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4</TotalTime>
  <Words>1228</Words>
  <Application>Microsoft Office PowerPoint</Application>
  <PresentationFormat>Custom</PresentationFormat>
  <Paragraphs>230</Paragraphs>
  <Slides>13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2" baseType="lpstr">
      <vt:lpstr>Assistant Regular</vt:lpstr>
      <vt:lpstr>Courier New</vt:lpstr>
      <vt:lpstr>Assistant ExtraBold</vt:lpstr>
      <vt:lpstr>Assistant</vt:lpstr>
      <vt:lpstr>Assistant Bold</vt:lpstr>
      <vt:lpstr>Calibri</vt:lpstr>
      <vt:lpstr>Arial</vt:lpstr>
      <vt:lpstr>Assistant Semi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339</cp:revision>
  <dcterms:created xsi:type="dcterms:W3CDTF">2006-08-16T00:00:00Z</dcterms:created>
  <dcterms:modified xsi:type="dcterms:W3CDTF">2023-11-03T20:57:53Z</dcterms:modified>
  <dc:identifier>DAE7nbwep5o</dc:identifier>
</cp:coreProperties>
</file>